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355" r:id="rId2"/>
    <p:sldId id="356" r:id="rId3"/>
    <p:sldId id="284" r:id="rId4"/>
    <p:sldId id="283" r:id="rId5"/>
    <p:sldId id="366" r:id="rId6"/>
    <p:sldId id="360" r:id="rId7"/>
    <p:sldId id="306" r:id="rId8"/>
    <p:sldId id="371" r:id="rId9"/>
    <p:sldId id="365" r:id="rId10"/>
    <p:sldId id="314" r:id="rId11"/>
    <p:sldId id="315" r:id="rId12"/>
  </p:sldIdLst>
  <p:sldSz cx="6858000" cy="9906000" type="A4"/>
  <p:notesSz cx="6797675" cy="992822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438" autoAdjust="0"/>
  </p:normalViewPr>
  <p:slideViewPr>
    <p:cSldViewPr>
      <p:cViewPr varScale="1">
        <p:scale>
          <a:sx n="44" d="100"/>
          <a:sy n="44" d="100"/>
        </p:scale>
        <p:origin x="2232" y="3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607E9-2C65-42BF-A6E7-703B146FEC8F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075249-2F59-4212-8F6B-9E245C83FA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3568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E075249-2F59-4212-8F6B-9E245C83FA78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35929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microsoft.com/office/2007/relationships/hdphoto" Target="../media/hdphoto1.wdp"/><Relationship Id="rId7" Type="http://schemas.openxmlformats.org/officeDocument/2006/relationships/image" Target="../media/image8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5" Type="http://schemas.microsoft.com/office/2007/relationships/hdphoto" Target="../media/hdphoto2.wdp"/><Relationship Id="rId10" Type="http://schemas.microsoft.com/office/2007/relationships/hdphoto" Target="../media/hdphoto3.wdp"/><Relationship Id="rId4" Type="http://schemas.openxmlformats.org/officeDocument/2006/relationships/image" Target="../media/image6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38A2C0B-82DD-C8DB-C9C6-DBD02E948A09}"/>
              </a:ext>
            </a:extLst>
          </p:cNvPr>
          <p:cNvSpPr txBox="1"/>
          <p:nvPr/>
        </p:nvSpPr>
        <p:spPr>
          <a:xfrm>
            <a:off x="21251" y="104245"/>
            <a:ext cx="155249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 S1</a:t>
            </a:r>
            <a:endParaRPr kumimoji="0" lang="zh-CN" altLang="en-US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3" name="Picture 2">
            <a:extLst>
              <a:ext uri="{FF2B5EF4-FFF2-40B4-BE49-F238E27FC236}">
                <a16:creationId xmlns:a16="http://schemas.microsoft.com/office/drawing/2014/main" id="{FB053E06-EE44-AE4C-4D45-096892F4E23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14" t="8455" r="48277" b="19292"/>
          <a:stretch/>
        </p:blipFill>
        <p:spPr bwMode="auto">
          <a:xfrm>
            <a:off x="1700808" y="2226018"/>
            <a:ext cx="1875597" cy="34901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2">
            <a:extLst>
              <a:ext uri="{FF2B5EF4-FFF2-40B4-BE49-F238E27FC236}">
                <a16:creationId xmlns:a16="http://schemas.microsoft.com/office/drawing/2014/main" id="{40774EEC-DADD-6780-8503-87344185AE3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55" t="10628" r="26935" b="17119"/>
          <a:stretch/>
        </p:blipFill>
        <p:spPr bwMode="auto">
          <a:xfrm>
            <a:off x="3655240" y="2222403"/>
            <a:ext cx="1875598" cy="3490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2">
            <a:extLst>
              <a:ext uri="{FF2B5EF4-FFF2-40B4-BE49-F238E27FC236}">
                <a16:creationId xmlns:a16="http://schemas.microsoft.com/office/drawing/2014/main" id="{39D6E254-6D26-C87A-AB6D-A25963F6E15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98" t="8388" r="18193" b="52218"/>
          <a:stretch/>
        </p:blipFill>
        <p:spPr bwMode="auto">
          <a:xfrm>
            <a:off x="1705997" y="301080"/>
            <a:ext cx="1875598" cy="1902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2">
            <a:extLst>
              <a:ext uri="{FF2B5EF4-FFF2-40B4-BE49-F238E27FC236}">
                <a16:creationId xmlns:a16="http://schemas.microsoft.com/office/drawing/2014/main" id="{697931A1-ABCA-0DE9-08CD-00CA8DB2E86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" t="15244" r="68182" b="45362"/>
          <a:stretch/>
        </p:blipFill>
        <p:spPr bwMode="auto">
          <a:xfrm>
            <a:off x="3660318" y="307441"/>
            <a:ext cx="1875598" cy="1902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2DF8D5BD-EEA0-B129-8A7C-9FAA59189C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8510" y="5746091"/>
            <a:ext cx="1875600" cy="3806921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42245B07-D3F0-2DDB-5223-6A790BE9447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60318" y="5738996"/>
            <a:ext cx="1890144" cy="3834164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9E0A4DD2-8AA8-A105-945D-E1759D6CC87A}"/>
              </a:ext>
            </a:extLst>
          </p:cNvPr>
          <p:cNvCxnSpPr/>
          <p:nvPr/>
        </p:nvCxnSpPr>
        <p:spPr>
          <a:xfrm>
            <a:off x="3316320" y="1701880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CB83E95-7317-5BE9-A481-D16B8F5978B7}"/>
              </a:ext>
            </a:extLst>
          </p:cNvPr>
          <p:cNvCxnSpPr/>
          <p:nvPr/>
        </p:nvCxnSpPr>
        <p:spPr>
          <a:xfrm>
            <a:off x="5188528" y="1685838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F9A5B25A-39EB-06A6-A3C6-1196E4190481}"/>
              </a:ext>
            </a:extLst>
          </p:cNvPr>
          <p:cNvCxnSpPr/>
          <p:nvPr/>
        </p:nvCxnSpPr>
        <p:spPr>
          <a:xfrm>
            <a:off x="3460336" y="5086256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AB01CA89-58B7-DF33-A151-7FDACB1A4651}"/>
              </a:ext>
            </a:extLst>
          </p:cNvPr>
          <p:cNvCxnSpPr/>
          <p:nvPr/>
        </p:nvCxnSpPr>
        <p:spPr>
          <a:xfrm>
            <a:off x="5332544" y="5070214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1E30F982-86F1-4A6A-3A2D-0219E3CD7717}"/>
              </a:ext>
            </a:extLst>
          </p:cNvPr>
          <p:cNvCxnSpPr/>
          <p:nvPr/>
        </p:nvCxnSpPr>
        <p:spPr>
          <a:xfrm>
            <a:off x="3388328" y="8902680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57C8D75C-E1D5-1375-C18A-99741811CBC9}"/>
              </a:ext>
            </a:extLst>
          </p:cNvPr>
          <p:cNvCxnSpPr/>
          <p:nvPr/>
        </p:nvCxnSpPr>
        <p:spPr>
          <a:xfrm>
            <a:off x="5260536" y="8886638"/>
            <a:ext cx="0" cy="3708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2C20ACE0-7604-5105-6B88-1042750C039E}"/>
              </a:ext>
            </a:extLst>
          </p:cNvPr>
          <p:cNvSpPr txBox="1"/>
          <p:nvPr/>
        </p:nvSpPr>
        <p:spPr>
          <a:xfrm>
            <a:off x="1890069" y="416496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A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B20D3D8-694E-DDEE-15A6-5EEBF0D60104}"/>
              </a:ext>
            </a:extLst>
          </p:cNvPr>
          <p:cNvSpPr txBox="1"/>
          <p:nvPr/>
        </p:nvSpPr>
        <p:spPr>
          <a:xfrm>
            <a:off x="3786447" y="419481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B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532A655-F457-8860-D40D-C3EC0E94C3D6}"/>
              </a:ext>
            </a:extLst>
          </p:cNvPr>
          <p:cNvSpPr txBox="1"/>
          <p:nvPr/>
        </p:nvSpPr>
        <p:spPr>
          <a:xfrm>
            <a:off x="1890331" y="2282397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C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4C0898B-6CBD-68A3-0F6D-996D2C2EB82D}"/>
              </a:ext>
            </a:extLst>
          </p:cNvPr>
          <p:cNvSpPr txBox="1"/>
          <p:nvPr/>
        </p:nvSpPr>
        <p:spPr>
          <a:xfrm>
            <a:off x="3781377" y="2276191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D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BEC8D78-1ED4-EE5B-7CC0-C09A01797D66}"/>
              </a:ext>
            </a:extLst>
          </p:cNvPr>
          <p:cNvSpPr txBox="1"/>
          <p:nvPr/>
        </p:nvSpPr>
        <p:spPr>
          <a:xfrm>
            <a:off x="1884544" y="5810789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E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0941182-36A8-C088-1E95-EF4D13D6F970}"/>
              </a:ext>
            </a:extLst>
          </p:cNvPr>
          <p:cNvSpPr txBox="1"/>
          <p:nvPr/>
        </p:nvSpPr>
        <p:spPr>
          <a:xfrm>
            <a:off x="3786033" y="5820081"/>
            <a:ext cx="307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3889928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10986A0F-5D5E-4195-A24A-358AA2A55FAC}"/>
              </a:ext>
            </a:extLst>
          </p:cNvPr>
          <p:cNvSpPr/>
          <p:nvPr/>
        </p:nvSpPr>
        <p:spPr>
          <a:xfrm>
            <a:off x="188640" y="245390"/>
            <a:ext cx="650745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2. The primers used in the artificial microRNA assays</a:t>
            </a:r>
            <a:endParaRPr lang="zh-CN" altLang="en-US" sz="14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86946206-6CFE-4987-B4A4-0E3EF61367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2490399"/>
              </p:ext>
            </p:extLst>
          </p:nvPr>
        </p:nvGraphicFramePr>
        <p:xfrm>
          <a:off x="173419" y="920552"/>
          <a:ext cx="6567949" cy="4725548"/>
        </p:xfrm>
        <a:graphic>
          <a:graphicData uri="http://schemas.openxmlformats.org/drawingml/2006/table">
            <a:tbl>
              <a:tblPr firstRow="1" firstCol="1" bandRow="1"/>
              <a:tblGrid>
                <a:gridCol w="1311365">
                  <a:extLst>
                    <a:ext uri="{9D8B030D-6E8A-4147-A177-3AD203B41FA5}">
                      <a16:colId xmlns:a16="http://schemas.microsoft.com/office/drawing/2014/main" val="1569526623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637143840"/>
                    </a:ext>
                  </a:extLst>
                </a:gridCol>
                <a:gridCol w="4176464">
                  <a:extLst>
                    <a:ext uri="{9D8B030D-6E8A-4147-A177-3AD203B41FA5}">
                      <a16:colId xmlns:a16="http://schemas.microsoft.com/office/drawing/2014/main" val="2136096741"/>
                    </a:ext>
                  </a:extLst>
                </a:gridCol>
              </a:tblGrid>
              <a:tr h="2775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900" kern="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urpos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i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/>
                          <a:cs typeface="Arial" panose="020B0604020202020204" pitchFamily="34" charset="0"/>
                        </a:rPr>
                        <a:t>Primer name</a:t>
                      </a:r>
                      <a:endParaRPr lang="zh-CN" altLang="zh-CN" sz="800" i="0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4877" marR="6487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800" i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/>
                          <a:cs typeface="Arial" panose="020B0604020202020204" pitchFamily="34" charset="0"/>
                        </a:rPr>
                        <a:t>Primer sequence (5’-3’)</a:t>
                      </a:r>
                      <a:endParaRPr lang="zh-CN" altLang="zh-CN" sz="800" i="0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4877" marR="64877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5897957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rtificial microRNA-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1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TACGAATTCGTAGACATGCAACTCTCTTTTGTATTCCA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7037506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1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TGCATGTCTACGAATTCGTATCAAAGAGAATCAATG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3383365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1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TACATGTCTACGTATTCGTTTCACAGGTCGTGATA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81745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1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V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ACGAATACGTAGACATGTAACTACATATATATTCCT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0079599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900" kern="10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Artificial</a:t>
                      </a:r>
                      <a:r>
                        <a:rPr lang="en-US" altLang="zh-CN" sz="900" kern="100" baseline="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croRNA-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2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TATATTGGATTACCAATGCAACTCTCTTTTGTATTCC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551761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2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TGCATTGGTAATCCAATATATCAAAGAGAATCAATG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546747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2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TACATTGGTAATGCAATATTTCACAGGTCGTGATA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4708313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2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V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ATATTGCATTACCAATGTAACTACATATATATTCCT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964280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900" kern="10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Artificial</a:t>
                      </a:r>
                      <a:r>
                        <a:rPr lang="en-US" altLang="zh-CN" sz="900" kern="100" baseline="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croRNA-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3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TAATTGTAGATATGGGTTCTCCTCTCTTTTGTATTCC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7759452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3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GAGAACCCATATCTACAATTATCAAAGAGAATCAATGA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2537264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3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GAAAACCCATATCAACAATTTTCACAGGTCGTGATATG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6399686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3-</a:t>
                      </a: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V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AATTGTTGATATGGGTTTTCCTACATATATATTCCTA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9907161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900" kern="10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Artificial</a:t>
                      </a:r>
                      <a:r>
                        <a:rPr lang="en-US" altLang="zh-CN" sz="900" kern="100" baseline="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croRNA-4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4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TAGACAGACGTACAGCCTCGACTCTCTTTTGTATTCC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8670649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4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CGAGGCTGTACGTCTGTCTATCAAAGAGAATCAATG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8003354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4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TCAAGGCTGTACGACTGTCTTTCACAGGTCGTGATATG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647217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4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V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AGACAGTCGTACAGCCTTGACTACATATATATTCCT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3907131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rtificial</a:t>
                      </a:r>
                      <a:r>
                        <a:rPr lang="en-US" sz="900" kern="100" baseline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croRNA-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5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TCATTCGACACGCAGACACGTCTCTCTTTTGTATTCC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9137466"/>
                  </a:ext>
                </a:extLst>
              </a:tr>
              <a:tr h="195976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5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ACGTGTCTGCGTGTCGAATGATCAAAGAGAATCAATG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3586490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5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II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ACATGTCTGCGTGACGAATGTTCACAGGTCGTGATATG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9847985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miRNA-5-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V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CATTCGTCACGCAGACATGTCTACATATATATTCCT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563203"/>
                  </a:ext>
                </a:extLst>
              </a:tr>
              <a:tr h="187565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9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Vector prime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19a-XbF-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TTATCTAGAACACACGCTCGGACGCAT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737009"/>
                  </a:ext>
                </a:extLst>
              </a:tr>
              <a:tr h="191771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19a-NcR-B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TTAATCCCATGGCGATGCCT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4877" marR="64877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68579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980008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49DC04C6-7928-4254-AE59-F1EAC111CAE9}"/>
              </a:ext>
            </a:extLst>
          </p:cNvPr>
          <p:cNvSpPr/>
          <p:nvPr/>
        </p:nvSpPr>
        <p:spPr>
          <a:xfrm>
            <a:off x="12427" y="252053"/>
            <a:ext cx="665693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3. The primers used in the  related vector construct, real-time PCR and RT-PCR assays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F06C3B0E-F2F4-4559-9FAE-BA21DF4CBA9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4730107"/>
              </p:ext>
            </p:extLst>
          </p:nvPr>
        </p:nvGraphicFramePr>
        <p:xfrm>
          <a:off x="620688" y="848544"/>
          <a:ext cx="5904656" cy="4547402"/>
        </p:xfrm>
        <a:graphic>
          <a:graphicData uri="http://schemas.openxmlformats.org/drawingml/2006/table">
            <a:tbl>
              <a:tblPr firstRow="1" firstCol="1" bandRow="1"/>
              <a:tblGrid>
                <a:gridCol w="1368152">
                  <a:extLst>
                    <a:ext uri="{9D8B030D-6E8A-4147-A177-3AD203B41FA5}">
                      <a16:colId xmlns:a16="http://schemas.microsoft.com/office/drawing/2014/main" val="226336740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1831802597"/>
                    </a:ext>
                  </a:extLst>
                </a:gridCol>
                <a:gridCol w="3024336">
                  <a:extLst>
                    <a:ext uri="{9D8B030D-6E8A-4147-A177-3AD203B41FA5}">
                      <a16:colId xmlns:a16="http://schemas.microsoft.com/office/drawing/2014/main" val="3423172671"/>
                    </a:ext>
                  </a:extLst>
                </a:gridCol>
              </a:tblGrid>
              <a:tr h="321530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 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/>
                          <a:cs typeface="Arial" panose="020B0604020202020204" pitchFamily="34" charset="0"/>
                        </a:rPr>
                        <a:t>Primer name</a:t>
                      </a:r>
                      <a:endParaRPr lang="zh-CN" altLang="zh-CN" sz="1000" i="0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5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0" kern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宋体"/>
                          <a:cs typeface="Arial" panose="020B0604020202020204" pitchFamily="34" charset="0"/>
                        </a:rPr>
                        <a:t>Primer sequence (5’-3’)</a:t>
                      </a:r>
                      <a:endParaRPr lang="zh-CN" altLang="zh-CN" sz="1000" i="0" kern="100" dirty="0"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504007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Tubulin</a:t>
                      </a:r>
                      <a:endParaRPr lang="zh-CN" altLang="zh-CN" sz="1000" kern="100" dirty="0"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UBULIN-L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TCGTATTTGGTCAATCCGGTG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3328841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UBULIN-R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ACATGGCTGAGGCTGTCAAGTA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332145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PC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-Ba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-LP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CAAACAACGTTTCGGTA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5597626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-Ba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-RP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TTACCAATGCAAGACGAAT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6547888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PD1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-PC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tpd1-LP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AGCCGGAGAGAATTGG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7420214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Ttpd1-R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CGAAGGCGACAGAGAGA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178440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PD1QPCR-prime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PD1QPCR-LP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GTGCAAGAGTACGGACATAG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1466876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PD1QPCR-RP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CAGACATACACTGGTTCGTTAT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0540876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en-US" sz="1000" i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QPCR</a:t>
                      </a: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PCR</a:t>
                      </a: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QPCR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FP</a:t>
                      </a: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CTGAGGCGGAGCTGCAATTAGAT</a:t>
                      </a: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9845734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QPCR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RP</a:t>
                      </a: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8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ATTGAAGGAGATTCGCGCTTGCAG</a:t>
                      </a:r>
                      <a:endParaRPr lang="en-US" alt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6515853"/>
                  </a:ext>
                </a:extLst>
              </a:tr>
              <a:tr h="195863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ctin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ctin2/8-FP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GTAACATTGTGCTCAGTGGTG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4270206"/>
                  </a:ext>
                </a:extLst>
              </a:tr>
              <a:tr h="56644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ctin2/8-R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CGACCTTAATCTTCATGCTGC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80248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1372328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a</a:t>
                      </a:r>
                      <a:r>
                        <a:rPr lang="en-US" sz="10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romote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a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Promoter-L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AGCTTGTGGAATACTCTTCTTTCCTAA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0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CP</a:t>
                      </a:r>
                      <a:r>
                        <a:rPr lang="en-US" altLang="zh-CN" sz="10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a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Promoter-RP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CTAGAGTGTTGTTGTGATATATTCTTC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US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vecto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US-1 (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deI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TATGATGTTACGTCCTGTAGAAAC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US-2 (</a:t>
                      </a:r>
                      <a:r>
                        <a:rPr lang="en-US" sz="10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acI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GCTCTCATTGTTTGCCTCCCTGC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pPr algn="just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NAi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vecto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NAi-CDS-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forward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CCATGGGATGTCATCATTATATTTTG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NAi-CDS-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forward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CTCGAGGTTAAGCCATTGAAGGAGAT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NAi-CDS-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everse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GGATCCGATGTCATCATTATATTTTG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1568">
                <a:tc>
                  <a:txBody>
                    <a:bodyPr/>
                    <a:lstStyle/>
                    <a:p>
                      <a:endParaRPr lang="zh-CN" sz="10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RNAi-CDS-</a:t>
                      </a:r>
                      <a:r>
                        <a:rPr lang="en-US" altLang="zh-CN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everse</a:t>
                      </a: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8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CTAGAGTTAAGCCATTGAAGGAGAT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66262" marR="6626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946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9EF771F3-BFFC-CC9F-AAAD-3E258B61C12F}"/>
              </a:ext>
            </a:extLst>
          </p:cNvPr>
          <p:cNvSpPr/>
          <p:nvPr/>
        </p:nvSpPr>
        <p:spPr>
          <a:xfrm>
            <a:off x="440668" y="1701602"/>
            <a:ext cx="5976664" cy="38625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600"/>
              </a:spcBef>
            </a:pPr>
            <a:r>
              <a:rPr lang="en-US" altLang="zh-CN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Figure S1. The silique phenotypic observation of the </a:t>
            </a:r>
            <a:r>
              <a:rPr lang="en-US" altLang="zh-CN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OE-TPD1 </a:t>
            </a:r>
            <a:r>
              <a:rPr lang="en-US" altLang="zh-CN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and wild type plants</a:t>
            </a:r>
          </a:p>
          <a:p>
            <a:pPr algn="ctr">
              <a:spcBef>
                <a:spcPts val="600"/>
              </a:spcBef>
            </a:pPr>
            <a:endParaRPr lang="zh-CN" altLang="zh-CN" sz="1600" kern="100" dirty="0">
              <a:solidFill>
                <a:prstClr val="black"/>
              </a:solidFill>
              <a:latin typeface="Times New Roman" panose="02020603050405020304" pitchFamily="18" charset="0"/>
            </a:endParaRPr>
          </a:p>
          <a:p>
            <a:pPr marL="400050" indent="-400050" algn="just"/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(A-B) The silique phenotype of wild type (A) and</a:t>
            </a:r>
            <a:r>
              <a:rPr lang="en-US" altLang="zh-CN" sz="16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 OE-TPD1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(B) at 10 stage of flower development;</a:t>
            </a:r>
          </a:p>
          <a:p>
            <a:pPr marL="400050" indent="-400050" algn="just"/>
            <a:endParaRPr lang="zh-CN" altLang="zh-CN" sz="1600" kern="100" dirty="0">
              <a:solidFill>
                <a:prstClr val="black"/>
              </a:solidFill>
              <a:latin typeface="Times New Roman" panose="02020603050405020304" pitchFamily="18" charset="0"/>
            </a:endParaRPr>
          </a:p>
          <a:p>
            <a:pPr marL="400050" marR="0" lvl="0" indent="-40005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(C-D) </a:t>
            </a:r>
            <a:r>
              <a:rPr kumimoji="0" lang="en-US" altLang="zh-CN" sz="1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The silique phenotype of wild type (C) and</a:t>
            </a:r>
            <a:r>
              <a:rPr kumimoji="0" lang="en-US" altLang="zh-CN" sz="16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OE-TPD1 </a:t>
            </a:r>
            <a:r>
              <a:rPr kumimoji="0" lang="en-US" altLang="zh-CN" sz="1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D) at 12 stage of flower development;</a:t>
            </a:r>
          </a:p>
          <a:p>
            <a:pPr marL="400050" marR="0" lvl="0" indent="-40005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1600" b="0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黑体" panose="02010609060101010101" pitchFamily="49" charset="-122"/>
              <a:cs typeface="+mn-cs"/>
            </a:endParaRPr>
          </a:p>
          <a:p>
            <a:pPr marL="400050" marR="0" lvl="0" indent="-40005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E-F) The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mature </a:t>
            </a:r>
            <a:r>
              <a:rPr kumimoji="0" lang="en-US" altLang="zh-CN" sz="1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silique phenotype of wild type (E) and</a:t>
            </a:r>
            <a:r>
              <a:rPr kumimoji="0" lang="en-US" altLang="zh-CN" sz="16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OE-TPD1 </a:t>
            </a:r>
            <a:r>
              <a:rPr kumimoji="0" lang="en-US" altLang="zh-CN" sz="16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F).</a:t>
            </a:r>
            <a:endParaRPr lang="en-US" altLang="zh-CN" sz="1600" kern="100" dirty="0">
              <a:solidFill>
                <a:srgbClr val="000000"/>
              </a:solidFill>
              <a:latin typeface="Times New Roman" panose="02020603050405020304" pitchFamily="18" charset="0"/>
              <a:ea typeface="黑体" panose="02010609060101010101" pitchFamily="49" charset="-122"/>
            </a:endParaRPr>
          </a:p>
          <a:p>
            <a:pPr algn="just"/>
            <a:endParaRPr lang="en-US" altLang="zh-CN" sz="1600" kern="100" dirty="0">
              <a:solidFill>
                <a:srgbClr val="000000"/>
              </a:solidFill>
              <a:latin typeface="Times New Roman" panose="02020603050405020304" pitchFamily="18" charset="0"/>
              <a:ea typeface="黑体" panose="02010609060101010101" pitchFamily="49" charset="-122"/>
            </a:endParaRPr>
          </a:p>
          <a:p>
            <a:pPr marR="0" lvl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US" altLang="zh-CN" sz="1600" b="0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黑体" panose="02010609060101010101" pitchFamily="49" charset="-122"/>
              <a:cs typeface="+mn-cs"/>
            </a:endParaRPr>
          </a:p>
          <a:p>
            <a:pPr algn="just"/>
            <a:endParaRPr lang="en-US" altLang="zh-CN" sz="1600" kern="100" dirty="0">
              <a:solidFill>
                <a:srgbClr val="000000"/>
              </a:solidFill>
              <a:latin typeface="Times New Roman" panose="02020603050405020304" pitchFamily="18" charset="0"/>
              <a:ea typeface="黑体" panose="02010609060101010101" pitchFamily="49" charset="-122"/>
            </a:endParaRPr>
          </a:p>
          <a:p>
            <a:pPr algn="just"/>
            <a:endParaRPr lang="en-US" altLang="zh-CN" sz="1600" kern="100" dirty="0">
              <a:solidFill>
                <a:srgbClr val="000000"/>
              </a:solidFill>
              <a:latin typeface="Times New Roman" panose="02020603050405020304" pitchFamily="18" charset="0"/>
              <a:ea typeface="黑体" panose="02010609060101010101" pitchFamily="49" charset="-122"/>
            </a:endParaRPr>
          </a:p>
          <a:p>
            <a:pPr algn="just"/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Bars = 1 mm (A-F).</a:t>
            </a:r>
            <a:endParaRPr lang="zh-CN" altLang="zh-CN" sz="1600" kern="100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1682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/>
          <p:cNvGrpSpPr/>
          <p:nvPr/>
        </p:nvGrpSpPr>
        <p:grpSpPr>
          <a:xfrm>
            <a:off x="476672" y="1479484"/>
            <a:ext cx="5534535" cy="6353836"/>
            <a:chOff x="937344" y="1280113"/>
            <a:chExt cx="5534535" cy="6353836"/>
          </a:xfrm>
        </p:grpSpPr>
        <p:grpSp>
          <p:nvGrpSpPr>
            <p:cNvPr id="32" name="组合 31"/>
            <p:cNvGrpSpPr/>
            <p:nvPr/>
          </p:nvGrpSpPr>
          <p:grpSpPr>
            <a:xfrm>
              <a:off x="937344" y="1280113"/>
              <a:ext cx="2699373" cy="2016703"/>
              <a:chOff x="-1205130" y="102019"/>
              <a:chExt cx="2699373" cy="2016703"/>
            </a:xfrm>
          </p:grpSpPr>
          <p:pic>
            <p:nvPicPr>
              <p:cNvPr id="2" name="Picture 3" descr="D:\personal\陈广霞论文及文章\陈广霞论文-2015-3-29-修改添加部分\最后筛选\40x good 第5期.jpg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7200"/>
                        </a14:imgEffect>
                        <a14:imgEffect>
                          <a14:saturation sat="66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54" t="24669" r="14814"/>
              <a:stretch/>
            </p:blipFill>
            <p:spPr bwMode="auto">
              <a:xfrm>
                <a:off x="-1205130" y="102019"/>
                <a:ext cx="2699373" cy="20167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3" name="直接连接符 2"/>
              <p:cNvCxnSpPr/>
              <p:nvPr/>
            </p:nvCxnSpPr>
            <p:spPr>
              <a:xfrm>
                <a:off x="908720" y="1995808"/>
                <a:ext cx="31409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TextBox 3"/>
            <p:cNvSpPr txBox="1"/>
            <p:nvPr/>
          </p:nvSpPr>
          <p:spPr>
            <a:xfrm>
              <a:off x="980325" y="1280113"/>
              <a:ext cx="2576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rPr>
                <a:t>A</a:t>
              </a:r>
              <a:endParaRPr kumimoji="0" lang="zh-CN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endParaRPr>
            </a:p>
          </p:txBody>
        </p:sp>
        <p:grpSp>
          <p:nvGrpSpPr>
            <p:cNvPr id="34" name="组合 33"/>
            <p:cNvGrpSpPr/>
            <p:nvPr/>
          </p:nvGrpSpPr>
          <p:grpSpPr>
            <a:xfrm>
              <a:off x="937345" y="5457056"/>
              <a:ext cx="2707679" cy="2016703"/>
              <a:chOff x="115841" y="6537176"/>
              <a:chExt cx="2707679" cy="2016703"/>
            </a:xfrm>
          </p:grpSpPr>
          <p:pic>
            <p:nvPicPr>
              <p:cNvPr id="8" name="Picture 5" descr="D:\personal\陈广霞论文及文章\陈广霞论文-2015-3-29-修改添加部分\最后筛选\40x 第7期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colorTemperature colorTemp="47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79" t="-267" r="6290" b="24935"/>
              <a:stretch/>
            </p:blipFill>
            <p:spPr bwMode="auto">
              <a:xfrm>
                <a:off x="124147" y="6537176"/>
                <a:ext cx="2699373" cy="20167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" name="直接连接符 8"/>
              <p:cNvCxnSpPr/>
              <p:nvPr/>
            </p:nvCxnSpPr>
            <p:spPr>
              <a:xfrm>
                <a:off x="2310004" y="8423452"/>
                <a:ext cx="31409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115841" y="6608705"/>
                <a:ext cx="25762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宋体" panose="02010600030101010101" pitchFamily="2" charset="-122"/>
                    <a:cs typeface="Times New Roman" pitchFamily="18" charset="0"/>
                  </a:rPr>
                  <a:t>C</a:t>
                </a:r>
                <a:endParaRPr kumimoji="0" lang="zh-CN" alt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endParaRPr>
              </a:p>
            </p:txBody>
          </p:sp>
        </p:grpSp>
        <p:grpSp>
          <p:nvGrpSpPr>
            <p:cNvPr id="11" name="组合 10"/>
            <p:cNvGrpSpPr/>
            <p:nvPr/>
          </p:nvGrpSpPr>
          <p:grpSpPr>
            <a:xfrm>
              <a:off x="3770498" y="1280113"/>
              <a:ext cx="2682838" cy="2016703"/>
              <a:chOff x="-2125855" y="2924944"/>
              <a:chExt cx="4243387" cy="3170237"/>
            </a:xfrm>
          </p:grpSpPr>
          <p:pic>
            <p:nvPicPr>
              <p:cNvPr id="12" name="Picture 2" descr="D:\personal\陈广霞论文及文章\陈广霞论文-2015-3-29-修改添加部分\最后筛选\20x 第9期-2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2125855" y="2924944"/>
                <a:ext cx="4243387" cy="31702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464488" y="5928970"/>
                <a:ext cx="464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-2125855" y="2924944"/>
                <a:ext cx="586192" cy="628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宋体" panose="02010600030101010101" pitchFamily="2" charset="-122"/>
                    <a:cs typeface="Times New Roman" pitchFamily="18" charset="0"/>
                  </a:rPr>
                  <a:t>D</a:t>
                </a:r>
                <a:endParaRPr kumimoji="0" lang="zh-CN" alt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endParaRPr>
              </a:p>
            </p:txBody>
          </p:sp>
        </p:grpSp>
        <p:grpSp>
          <p:nvGrpSpPr>
            <p:cNvPr id="15" name="组合 14"/>
            <p:cNvGrpSpPr/>
            <p:nvPr/>
          </p:nvGrpSpPr>
          <p:grpSpPr>
            <a:xfrm>
              <a:off x="3770498" y="3356580"/>
              <a:ext cx="2682838" cy="2016704"/>
              <a:chOff x="2201699" y="2924944"/>
              <a:chExt cx="4243387" cy="3170238"/>
            </a:xfrm>
          </p:grpSpPr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41" t="20610" r="12984" b="17407"/>
              <a:stretch/>
            </p:blipFill>
            <p:spPr bwMode="auto">
              <a:xfrm>
                <a:off x="2201699" y="2924944"/>
                <a:ext cx="4243387" cy="31702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17" name="直接连接符 16"/>
              <p:cNvCxnSpPr/>
              <p:nvPr/>
            </p:nvCxnSpPr>
            <p:spPr>
              <a:xfrm>
                <a:off x="5500568" y="5918610"/>
                <a:ext cx="7488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2201699" y="2924944"/>
                <a:ext cx="563375" cy="628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宋体" panose="02010600030101010101" pitchFamily="2" charset="-122"/>
                    <a:cs typeface="Times New Roman" pitchFamily="18" charset="0"/>
                  </a:rPr>
                  <a:t>E</a:t>
                </a:r>
                <a:endParaRPr kumimoji="0" lang="zh-CN" alt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3789040" y="5457056"/>
              <a:ext cx="2682839" cy="2016704"/>
              <a:chOff x="6534947" y="2924943"/>
              <a:chExt cx="4243388" cy="3170238"/>
            </a:xfrm>
          </p:grpSpPr>
          <p:pic>
            <p:nvPicPr>
              <p:cNvPr id="20" name="Picture 4" descr="D:\personal\陈广霞论文及文章\陈广霞论文-2015-3-29-修改添加部分\最后筛选\20x 第11期.jp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66" t="9235" r="17405" b="9235"/>
              <a:stretch/>
            </p:blipFill>
            <p:spPr bwMode="auto">
              <a:xfrm>
                <a:off x="6534947" y="2924943"/>
                <a:ext cx="4243388" cy="31702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1" name="直接连接符 20"/>
              <p:cNvCxnSpPr/>
              <p:nvPr/>
            </p:nvCxnSpPr>
            <p:spPr>
              <a:xfrm>
                <a:off x="10021144" y="5918610"/>
                <a:ext cx="57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/>
              <p:cNvSpPr txBox="1"/>
              <p:nvPr/>
            </p:nvSpPr>
            <p:spPr>
              <a:xfrm>
                <a:off x="6552580" y="2924945"/>
                <a:ext cx="540554" cy="628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宋体" panose="02010600030101010101" pitchFamily="2" charset="-122"/>
                    <a:cs typeface="Times New Roman" pitchFamily="18" charset="0"/>
                  </a:rPr>
                  <a:t>F</a:t>
                </a:r>
                <a:endParaRPr kumimoji="0" lang="zh-CN" alt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endParaRPr>
              </a:p>
            </p:txBody>
          </p:sp>
        </p:grpSp>
        <p:grpSp>
          <p:nvGrpSpPr>
            <p:cNvPr id="33" name="组合 32"/>
            <p:cNvGrpSpPr/>
            <p:nvPr/>
          </p:nvGrpSpPr>
          <p:grpSpPr>
            <a:xfrm>
              <a:off x="937344" y="3356581"/>
              <a:ext cx="2707680" cy="2016703"/>
              <a:chOff x="289272" y="3356581"/>
              <a:chExt cx="2707680" cy="2016703"/>
            </a:xfrm>
          </p:grpSpPr>
          <p:pic>
            <p:nvPicPr>
              <p:cNvPr id="5" name="Picture 4" descr="D:\personal\陈广霞论文及文章\陈广霞论文-2015-3-29-修改添加部分\最后筛选\40x 第6期.JPG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colorTemperature colorTemp="47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2" t="8920" r="20558" b="15748"/>
              <a:stretch/>
            </p:blipFill>
            <p:spPr bwMode="auto">
              <a:xfrm>
                <a:off x="297579" y="3356581"/>
                <a:ext cx="2699373" cy="20167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6" name="直接连接符 5"/>
              <p:cNvCxnSpPr/>
              <p:nvPr/>
            </p:nvCxnSpPr>
            <p:spPr>
              <a:xfrm>
                <a:off x="2555444" y="5239364"/>
                <a:ext cx="31409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289272" y="3356582"/>
                <a:ext cx="24647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itchFamily="18" charset="0"/>
                    <a:ea typeface="宋体" panose="02010600030101010101" pitchFamily="2" charset="-122"/>
                    <a:cs typeface="Times New Roman" pitchFamily="18" charset="0"/>
                  </a:rPr>
                  <a:t>B</a:t>
                </a:r>
                <a:endParaRPr kumimoji="0" lang="zh-CN" alt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宋体" panose="02010600030101010101" pitchFamily="2" charset="-122"/>
                  <a:cs typeface="Times New Roman" pitchFamily="18" charset="0"/>
                </a:endParaRPr>
              </a:p>
            </p:txBody>
          </p:sp>
          <p:sp>
            <p:nvSpPr>
              <p:cNvPr id="25" name="等腰三角形 24"/>
              <p:cNvSpPr/>
              <p:nvPr/>
            </p:nvSpPr>
            <p:spPr>
              <a:xfrm rot="8571773">
                <a:off x="2002405" y="3807641"/>
                <a:ext cx="113803" cy="114505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宋体" panose="02010600030101010101" pitchFamily="2" charset="-122"/>
                  <a:cs typeface="+mn-cs"/>
                </a:endParaRPr>
              </a:p>
            </p:txBody>
          </p:sp>
        </p:grpSp>
        <p:sp>
          <p:nvSpPr>
            <p:cNvPr id="27" name="等腰三角形 26"/>
            <p:cNvSpPr/>
            <p:nvPr/>
          </p:nvSpPr>
          <p:spPr>
            <a:xfrm rot="8571773">
              <a:off x="1867849" y="7120009"/>
              <a:ext cx="113803" cy="114505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28" name="等腰三角形 27"/>
            <p:cNvSpPr/>
            <p:nvPr/>
          </p:nvSpPr>
          <p:spPr>
            <a:xfrm rot="8571773">
              <a:off x="6183261" y="7519444"/>
              <a:ext cx="113803" cy="114505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endParaRPr>
            </a:p>
          </p:txBody>
        </p:sp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77E1930E-4F19-9159-E466-981040C2F638}"/>
              </a:ext>
            </a:extLst>
          </p:cNvPr>
          <p:cNvSpPr txBox="1"/>
          <p:nvPr/>
        </p:nvSpPr>
        <p:spPr>
          <a:xfrm>
            <a:off x="247566" y="408872"/>
            <a:ext cx="3432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</a:rPr>
              <a:t>Figure S2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4091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5"/>
          <p:cNvSpPr/>
          <p:nvPr/>
        </p:nvSpPr>
        <p:spPr>
          <a:xfrm>
            <a:off x="188640" y="560512"/>
            <a:ext cx="6408712" cy="53285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6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Figure S2. </a:t>
            </a:r>
            <a:r>
              <a:rPr kumimoji="0" lang="en-US" altLang="zh-CN" sz="1400" b="1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1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 </a:t>
            </a:r>
            <a:r>
              <a:rPr kumimoji="0" lang="en-US" altLang="zh-CN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was expressed in tapetal cells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A)  The section of the anther at stage 5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 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B)  The section of the anther at stage 6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C)  The section of the anther at stage 7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D)  The section of the anther at stage 9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E)  The section of the anther at stage 10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(F)  The section of the anther at stage 11 from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The black arrows indicate tapetum. Bars = 20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μm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(A - C); Bars = 50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μm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(D - F).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1400" b="0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黑体" panose="02010609060101010101" pitchFamily="49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The section of the anther at stage 5 (A), 6 (B), 7 (C), 8 (D), 9 (E), 10 (F) from </a:t>
            </a: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p</a:t>
            </a:r>
            <a:r>
              <a:rPr kumimoji="0" lang="en-US" altLang="zh-CN" sz="1400" b="0" i="1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AtPCP</a:t>
            </a:r>
            <a:r>
              <a:rPr kumimoji="0" lang="en-US" altLang="zh-CN" sz="1400" b="0" i="1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-Ba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::GUS transgenic plant;</a:t>
            </a:r>
            <a:endParaRPr kumimoji="0" lang="en-US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The black arrows indicate tapetum. Bars = 20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μm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(A - C); Bars = 50 </a:t>
            </a:r>
            <a:r>
              <a:rPr kumimoji="0" lang="en-US" altLang="zh-CN" sz="1400" b="0" i="0" u="none" strike="noStrike" kern="1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μm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 (D - F).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552423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7C117881-A24C-43D2-AB37-86BDA05A081C}"/>
              </a:ext>
            </a:extLst>
          </p:cNvPr>
          <p:cNvSpPr/>
          <p:nvPr/>
        </p:nvSpPr>
        <p:spPr>
          <a:xfrm>
            <a:off x="380793" y="7425294"/>
            <a:ext cx="6168330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338"/>
              </a:spcBef>
              <a:defRPr/>
            </a:pP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igure S3. </a:t>
            </a:r>
            <a:r>
              <a:rPr lang="en-US" altLang="zh-CN" sz="1400" b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tPCP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-Ba protein contains a N-terminal signal peptide</a:t>
            </a:r>
            <a:endParaRPr lang="zh-CN" altLang="zh-CN" sz="1400" kern="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92916" indent="-192916" algn="just">
              <a:lnSpc>
                <a:spcPct val="200000"/>
              </a:lnSpc>
              <a:buFont typeface="+mj-lt"/>
              <a:buAutoNum type="alphaUcParenBoth"/>
              <a:defRPr/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he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tPCP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-Ba was a protein with signal peptide using  signalP-4.1 prediction software;</a:t>
            </a:r>
          </a:p>
          <a:p>
            <a:pPr marL="192916" indent="-192916" algn="just">
              <a:lnSpc>
                <a:spcPct val="200000"/>
              </a:lnSpc>
              <a:buFont typeface="+mj-lt"/>
              <a:buAutoNum type="alphaUcParenBoth"/>
              <a:defRPr/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he TPD1 was a protein with signal peptide using  signalP-4.1 prediction software.</a:t>
            </a:r>
          </a:p>
        </p:txBody>
      </p:sp>
      <p:sp>
        <p:nvSpPr>
          <p:cNvPr id="4" name="矩形 3"/>
          <p:cNvSpPr/>
          <p:nvPr/>
        </p:nvSpPr>
        <p:spPr>
          <a:xfrm>
            <a:off x="0" y="-50559"/>
            <a:ext cx="1800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sz="2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E13741C-5BC4-4EBD-9F8A-A2215CB091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42" t="42595"/>
          <a:stretch/>
        </p:blipFill>
        <p:spPr>
          <a:xfrm>
            <a:off x="1292556" y="2524763"/>
            <a:ext cx="4272887" cy="4856474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212998" y="447110"/>
            <a:ext cx="3706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60508" y="2648744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5E83FF19-BB35-6433-D501-3FBE3E398B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2556" y="471818"/>
            <a:ext cx="4939432" cy="1992233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B9B6D2BB-43F2-CAB9-8A63-8118990D453D}"/>
              </a:ext>
            </a:extLst>
          </p:cNvPr>
          <p:cNvSpPr/>
          <p:nvPr/>
        </p:nvSpPr>
        <p:spPr>
          <a:xfrm>
            <a:off x="160408" y="5169024"/>
            <a:ext cx="3561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zh-CN" sz="2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2556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1A3D843-B4FD-AD49-9C50-EA73BF34F5E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73"/>
          <a:stretch/>
        </p:blipFill>
        <p:spPr>
          <a:xfrm>
            <a:off x="260648" y="515402"/>
            <a:ext cx="6316936" cy="8677366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8C4787F-50CA-133D-C03F-E1DB2C6D0BF9}"/>
              </a:ext>
            </a:extLst>
          </p:cNvPr>
          <p:cNvSpPr txBox="1"/>
          <p:nvPr/>
        </p:nvSpPr>
        <p:spPr>
          <a:xfrm>
            <a:off x="260648" y="267387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A176A7A-7A2C-83F9-2755-6FE00992A97B}"/>
              </a:ext>
            </a:extLst>
          </p:cNvPr>
          <p:cNvSpPr txBox="1"/>
          <p:nvPr/>
        </p:nvSpPr>
        <p:spPr>
          <a:xfrm>
            <a:off x="2196516" y="239277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6235AA7-1C76-7B89-FBCB-AB1E8AA5D42D}"/>
              </a:ext>
            </a:extLst>
          </p:cNvPr>
          <p:cNvSpPr txBox="1"/>
          <p:nvPr/>
        </p:nvSpPr>
        <p:spPr>
          <a:xfrm>
            <a:off x="4387050" y="267387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D61C248-99AA-B3FF-4F8D-C3594E262059}"/>
              </a:ext>
            </a:extLst>
          </p:cNvPr>
          <p:cNvSpPr txBox="1"/>
          <p:nvPr/>
        </p:nvSpPr>
        <p:spPr>
          <a:xfrm>
            <a:off x="107011" y="4953000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CB4A379-B1DE-92A8-26BC-865B7D3DC93C}"/>
              </a:ext>
            </a:extLst>
          </p:cNvPr>
          <p:cNvSpPr txBox="1"/>
          <p:nvPr/>
        </p:nvSpPr>
        <p:spPr>
          <a:xfrm>
            <a:off x="130512" y="6220191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1590CE8-DE89-1F85-B716-A38CC7D72C6C}"/>
              </a:ext>
            </a:extLst>
          </p:cNvPr>
          <p:cNvSpPr txBox="1"/>
          <p:nvPr/>
        </p:nvSpPr>
        <p:spPr>
          <a:xfrm>
            <a:off x="93709" y="7487382"/>
            <a:ext cx="30727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B3B70AF-A5FA-7D1F-EFC8-C4EB3451AC64}"/>
              </a:ext>
            </a:extLst>
          </p:cNvPr>
          <p:cNvSpPr/>
          <p:nvPr/>
        </p:nvSpPr>
        <p:spPr>
          <a:xfrm>
            <a:off x="28600" y="-22333"/>
            <a:ext cx="26803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18604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52636" y="1712640"/>
            <a:ext cx="655272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黑体" panose="02010609060101010101" pitchFamily="49" charset="-122"/>
                <a:cs typeface="+mn-cs"/>
              </a:rPr>
              <a:t>FigureS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altLang="zh-CN" sz="1600" i="0" u="none" strike="noStrike" kern="1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黑体" panose="02010609060101010101" pitchFamily="49" charset="-122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hylogenetic tree(A)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structure(B), and conserved motif(C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 flower and silique CRP protein sequences in </a:t>
            </a:r>
            <a:r>
              <a:rPr kumimoji="0" lang="en-US" altLang="zh-CN" sz="160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rabidopsis</a:t>
            </a: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kumimoji="0" lang="en-US" altLang="zh-CN" sz="1600" i="1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Zea</a:t>
            </a:r>
            <a:r>
              <a:rPr kumimoji="0" lang="en-US" altLang="zh-CN" sz="160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ays</a:t>
            </a: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ryza sativa </a:t>
            </a: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kumimoji="0" lang="en-US" altLang="zh-CN" sz="160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orghum bicolor</a:t>
            </a:r>
            <a:r>
              <a:rPr kumimoji="0" lang="en-US" altLang="zh-CN" sz="16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kumimoji="0" lang="zh-CN" altLang="en-US" sz="160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73478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0" t="1525" b="1369"/>
          <a:stretch/>
        </p:blipFill>
        <p:spPr bwMode="auto">
          <a:xfrm>
            <a:off x="45000" y="848544"/>
            <a:ext cx="6768000" cy="86383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9F4A221A-0830-4A04-A5D8-4B32759EB3A0}"/>
              </a:ext>
            </a:extLst>
          </p:cNvPr>
          <p:cNvSpPr/>
          <p:nvPr/>
        </p:nvSpPr>
        <p:spPr>
          <a:xfrm>
            <a:off x="623439" y="203847"/>
            <a:ext cx="5427768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ts val="1800"/>
              </a:lnSpc>
              <a:spcBef>
                <a:spcPts val="600"/>
              </a:spcBef>
              <a:defRPr/>
            </a:pPr>
            <a:r>
              <a:rPr lang="en-GB" altLang="zh-CN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Figure S5 Expression patterns of </a:t>
            </a:r>
            <a:r>
              <a:rPr lang="en-GB" altLang="zh-CN" b="1" i="1" kern="100" dirty="0">
                <a:solidFill>
                  <a:srgbClr val="FF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PCP-B</a:t>
            </a:r>
            <a:r>
              <a:rPr lang="en-GB" altLang="zh-CN" b="1" kern="100" dirty="0">
                <a:solidFill>
                  <a:srgbClr val="FF0000"/>
                </a:solidFill>
                <a:latin typeface="Times New Roman" panose="02020603050405020304" pitchFamily="18" charset="0"/>
                <a:ea typeface="黑体" panose="02010609060101010101" pitchFamily="49" charset="-122"/>
              </a:rPr>
              <a:t> family genes</a:t>
            </a:r>
            <a:endParaRPr lang="zh-CN" altLang="zh-CN" sz="2400" kern="100" dirty="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46422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16632" y="468531"/>
            <a:ext cx="6552728" cy="710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63305" tIns="31652" rIns="63305" bIns="31652" numCol="1" anchor="ctr" anchorCtr="0" compatLnSpc="1">
            <a:prstTxWarp prst="textNoShape">
              <a:avLst/>
            </a:prstTxWarp>
            <a:spAutoFit/>
          </a:bodyPr>
          <a:lstStyle/>
          <a:p>
            <a:pPr indent="184636" defTabSz="633039" fontAlgn="base">
              <a:lnSpc>
                <a:spcPct val="150000"/>
              </a:lnSpc>
              <a:spcBef>
                <a:spcPts val="2400"/>
              </a:spcBef>
              <a:spcAft>
                <a:spcPct val="0"/>
              </a:spcAft>
              <a:defRPr/>
            </a:pPr>
            <a:r>
              <a:rPr lang="en-US" altLang="zh-CN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microarray assay showed that the expression of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PCP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Ba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 significantly affected in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E-TPD1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d1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s1 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ants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44C38B41-19D9-4622-ACA8-6F73A5350953}"/>
              </a:ext>
            </a:extLst>
          </p:cNvPr>
          <p:cNvGraphicFramePr>
            <a:graphicFrameLocks noGrp="1"/>
          </p:cNvGraphicFramePr>
          <p:nvPr/>
        </p:nvGraphicFramePr>
        <p:xfrm>
          <a:off x="112783" y="1856656"/>
          <a:ext cx="6628585" cy="557931"/>
        </p:xfrm>
        <a:graphic>
          <a:graphicData uri="http://schemas.openxmlformats.org/drawingml/2006/table">
            <a:tbl>
              <a:tblPr firstRow="1" firstCol="1" bandRow="1"/>
              <a:tblGrid>
                <a:gridCol w="1419432">
                  <a:extLst>
                    <a:ext uri="{9D8B030D-6E8A-4147-A177-3AD203B41FA5}">
                      <a16:colId xmlns:a16="http://schemas.microsoft.com/office/drawing/2014/main" val="1388801467"/>
                    </a:ext>
                  </a:extLst>
                </a:gridCol>
                <a:gridCol w="1248713">
                  <a:extLst>
                    <a:ext uri="{9D8B030D-6E8A-4147-A177-3AD203B41FA5}">
                      <a16:colId xmlns:a16="http://schemas.microsoft.com/office/drawing/2014/main" val="965582602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820511140"/>
                    </a:ext>
                  </a:extLst>
                </a:gridCol>
                <a:gridCol w="1152128">
                  <a:extLst>
                    <a:ext uri="{9D8B030D-6E8A-4147-A177-3AD203B41FA5}">
                      <a16:colId xmlns:a16="http://schemas.microsoft.com/office/drawing/2014/main" val="2311497927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val="3166704328"/>
                    </a:ext>
                  </a:extLst>
                </a:gridCol>
              </a:tblGrid>
              <a:tr h="237891"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GI Locus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FC(OE-TPD1/</a:t>
                      </a:r>
                      <a:r>
                        <a:rPr lang="en-US" altLang="zh-CN" sz="1050" kern="1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Ler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FC(tpd1/</a:t>
                      </a:r>
                      <a:r>
                        <a:rPr lang="en-US" altLang="zh-CN" sz="1050" kern="1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ler</a:t>
                      </a:r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FC(ems1/</a:t>
                      </a:r>
                      <a:r>
                        <a:rPr lang="en-US" altLang="zh-CN" sz="1050" kern="1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Ler</a:t>
                      </a:r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Gene  Annotation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9473405"/>
                  </a:ext>
                </a:extLst>
              </a:tr>
              <a:tr h="266165">
                <a:tc>
                  <a:txBody>
                    <a:bodyPr/>
                    <a:lstStyle/>
                    <a:p>
                      <a:r>
                        <a:rPr lang="en-US" altLang="zh-CN" sz="1050" i="1" kern="100" dirty="0" err="1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tPCP</a:t>
                      </a:r>
                      <a:r>
                        <a:rPr lang="en-US" altLang="zh-CN" sz="1050" i="1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-Ba</a:t>
                      </a:r>
                      <a:endParaRPr lang="zh-CN" sz="1050" i="1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.1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-2.7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-3.2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50" kern="1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EMBRYO SURROUNDING FACTOR-like protein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71" marR="6857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0675933"/>
                  </a:ext>
                </a:extLst>
              </a:tr>
            </a:tbl>
          </a:graphicData>
        </a:graphic>
      </p:graphicFrame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068162" y="3375556"/>
            <a:ext cx="2649667" cy="248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63305" tIns="31652" rIns="63305" bIns="31652" numCol="1" anchor="ctr" anchorCtr="0" compatLnSpc="1">
            <a:prstTxWarp prst="textNoShape">
              <a:avLst/>
            </a:prstTxWarp>
            <a:spAutoFit/>
          </a:bodyPr>
          <a:lstStyle/>
          <a:p>
            <a:pPr indent="184636" defTabSz="633039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d Change = Log2 (mutant /WT)</a:t>
            </a:r>
          </a:p>
        </p:txBody>
      </p:sp>
    </p:spTree>
    <p:extLst>
      <p:ext uri="{BB962C8B-B14F-4D97-AF65-F5344CB8AC3E}">
        <p14:creationId xmlns:p14="http://schemas.microsoft.com/office/powerpoint/2010/main" val="118389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06</TotalTime>
  <Words>641</Words>
  <Application>Microsoft Office PowerPoint</Application>
  <PresentationFormat>A4 纸张(210x297 毫米)</PresentationFormat>
  <Paragraphs>195</Paragraphs>
  <Slides>1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6" baseType="lpstr">
      <vt:lpstr>等线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小宾 吴</cp:lastModifiedBy>
  <cp:revision>211</cp:revision>
  <cp:lastPrinted>2024-03-05T03:13:33Z</cp:lastPrinted>
  <dcterms:created xsi:type="dcterms:W3CDTF">2021-10-26T07:18:35Z</dcterms:created>
  <dcterms:modified xsi:type="dcterms:W3CDTF">2024-09-18T06:54:46Z</dcterms:modified>
</cp:coreProperties>
</file>